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1704" y="3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upur Mittal" userId="ba77d09e-0cb3-4c62-b289-e2ab16e234f7" providerId="ADAL" clId="{67855DEA-677F-4244-8607-003DFA6C4BCF}"/>
    <pc:docChg chg="modSld">
      <pc:chgData name="Nupur Mittal" userId="ba77d09e-0cb3-4c62-b289-e2ab16e234f7" providerId="ADAL" clId="{67855DEA-677F-4244-8607-003DFA6C4BCF}" dt="2022-01-11T21:34:06.053" v="2" actId="255"/>
      <pc:docMkLst>
        <pc:docMk/>
      </pc:docMkLst>
      <pc:sldChg chg="modSp mod">
        <pc:chgData name="Nupur Mittal" userId="ba77d09e-0cb3-4c62-b289-e2ab16e234f7" providerId="ADAL" clId="{67855DEA-677F-4244-8607-003DFA6C4BCF}" dt="2022-01-11T21:34:06.053" v="2" actId="255"/>
        <pc:sldMkLst>
          <pc:docMk/>
          <pc:sldMk cId="782069109" sldId="257"/>
        </pc:sldMkLst>
        <pc:spChg chg="mod">
          <ac:chgData name="Nupur Mittal" userId="ba77d09e-0cb3-4c62-b289-e2ab16e234f7" providerId="ADAL" clId="{67855DEA-677F-4244-8607-003DFA6C4BCF}" dt="2022-01-11T21:34:06.053" v="2" actId="255"/>
          <ac:spMkLst>
            <pc:docMk/>
            <pc:sldMk cId="782069109" sldId="257"/>
            <ac:spMk id="2" creationId="{B75AD480-85CC-4EEF-AE02-849DB94D710A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6084A60-D282-4974-AE5C-BA7BAC5C302B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4B670A3-1425-46E1-89AA-BC26AC9932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04116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 Fig 1 (a-f) Associations between program demographics and some barriers/facilitators</a:t>
            </a:r>
            <a:r>
              <a:rPr lang="en-US" baseline="0" dirty="0"/>
              <a:t> </a:t>
            </a:r>
            <a:r>
              <a:rPr lang="en-US" dirty="0"/>
              <a:t>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3812674-CF53-40CE-BD06-719147FAA6A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46163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C53D6-291B-441E-A865-B08279DE9F2C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3363F5-6F31-4DCE-A0FD-F09CE1DAF5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90423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C53D6-291B-441E-A865-B08279DE9F2C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3363F5-6F31-4DCE-A0FD-F09CE1DAF5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89372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C53D6-291B-441E-A865-B08279DE9F2C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3363F5-6F31-4DCE-A0FD-F09CE1DAF5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75857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C53D6-291B-441E-A865-B08279DE9F2C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3363F5-6F31-4DCE-A0FD-F09CE1DAF5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82689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C53D6-291B-441E-A865-B08279DE9F2C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3363F5-6F31-4DCE-A0FD-F09CE1DAF5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72353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C53D6-291B-441E-A865-B08279DE9F2C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3363F5-6F31-4DCE-A0FD-F09CE1DAF5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74613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C53D6-291B-441E-A865-B08279DE9F2C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3363F5-6F31-4DCE-A0FD-F09CE1DAF5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53174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C53D6-291B-441E-A865-B08279DE9F2C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3363F5-6F31-4DCE-A0FD-F09CE1DAF5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67924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C53D6-291B-441E-A865-B08279DE9F2C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3363F5-6F31-4DCE-A0FD-F09CE1DAF5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17766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C53D6-291B-441E-A865-B08279DE9F2C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3363F5-6F31-4DCE-A0FD-F09CE1DAF5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199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1C53D6-291B-441E-A865-B08279DE9F2C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3363F5-6F31-4DCE-A0FD-F09CE1DAF5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74273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1C53D6-291B-441E-A865-B08279DE9F2C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3363F5-6F31-4DCE-A0FD-F09CE1DAF5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20756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44334628-175A-4BB0-9CA9-A994F98C11F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69470014"/>
              </p:ext>
            </p:extLst>
          </p:nvPr>
        </p:nvGraphicFramePr>
        <p:xfrm>
          <a:off x="27641" y="445915"/>
          <a:ext cx="2929569" cy="31089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4207826" imgH="3349793" progId="Prism8.Document">
                  <p:embed/>
                </p:oleObj>
              </mc:Choice>
              <mc:Fallback>
                <p:oleObj name="Prism 8" r:id="rId3" imgW="4207826" imgH="3349793" progId="Prism8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44334628-175A-4BB0-9CA9-A994F98C11F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7641" y="445915"/>
                        <a:ext cx="2929569" cy="31089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FC22E14B-15A4-45A0-88B4-57C51B32FD2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1858680"/>
              </p:ext>
            </p:extLst>
          </p:nvPr>
        </p:nvGraphicFramePr>
        <p:xfrm>
          <a:off x="2941017" y="434028"/>
          <a:ext cx="2903047" cy="31089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5" imgW="4171092" imgH="3349793" progId="Prism8.Document">
                  <p:embed/>
                </p:oleObj>
              </mc:Choice>
              <mc:Fallback>
                <p:oleObj name="Prism 8" r:id="rId5" imgW="4171092" imgH="3349793" progId="Prism8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FC22E14B-15A4-45A0-88B4-57C51B32FD2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941017" y="434028"/>
                        <a:ext cx="2903047" cy="31089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B2C17034-99E0-4439-BA9D-3754C840CEF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41585380"/>
              </p:ext>
            </p:extLst>
          </p:nvPr>
        </p:nvGraphicFramePr>
        <p:xfrm>
          <a:off x="27642" y="3537808"/>
          <a:ext cx="2929569" cy="31089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7" imgW="4207826" imgH="3349793" progId="Prism8.Document">
                  <p:embed/>
                </p:oleObj>
              </mc:Choice>
              <mc:Fallback>
                <p:oleObj name="Prism 8" r:id="rId7" imgW="4207826" imgH="3349793" progId="Prism8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B2C17034-99E0-4439-BA9D-3754C840CEF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7642" y="3537808"/>
                        <a:ext cx="2929569" cy="31089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C62ED6C0-5D61-4F85-A06C-55C685331FE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1552690"/>
              </p:ext>
            </p:extLst>
          </p:nvPr>
        </p:nvGraphicFramePr>
        <p:xfrm>
          <a:off x="2941017" y="3530417"/>
          <a:ext cx="2903047" cy="31089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9" imgW="4171092" imgH="3349793" progId="Prism8.Document">
                  <p:embed/>
                </p:oleObj>
              </mc:Choice>
              <mc:Fallback>
                <p:oleObj name="Prism 8" r:id="rId9" imgW="4171092" imgH="3349793" progId="Prism8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C62ED6C0-5D61-4F85-A06C-55C685331FE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941017" y="3530417"/>
                        <a:ext cx="2903047" cy="31089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D143F859-1791-45C2-BB50-ED753DEBE3E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08626813"/>
              </p:ext>
            </p:extLst>
          </p:nvPr>
        </p:nvGraphicFramePr>
        <p:xfrm>
          <a:off x="5721565" y="434028"/>
          <a:ext cx="3361655" cy="31089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1" imgW="4829780" imgH="3349793" progId="Prism8.Document">
                  <p:embed/>
                </p:oleObj>
              </mc:Choice>
              <mc:Fallback>
                <p:oleObj name="Prism 8" r:id="rId11" imgW="4829780" imgH="3349793" progId="Prism8.Document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D143F859-1791-45C2-BB50-ED753DEBE3E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5721565" y="434028"/>
                        <a:ext cx="3361655" cy="31089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7ED16F27-0305-4E4A-B984-D118ED8E729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77313731"/>
              </p:ext>
            </p:extLst>
          </p:nvPr>
        </p:nvGraphicFramePr>
        <p:xfrm>
          <a:off x="5684955" y="3511292"/>
          <a:ext cx="3483214" cy="31089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3" imgW="5003726" imgH="3349793" progId="Prism8.Document">
                  <p:embed/>
                </p:oleObj>
              </mc:Choice>
              <mc:Fallback>
                <p:oleObj name="Prism 8" r:id="rId13" imgW="5003726" imgH="3349793" progId="Prism8.Document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7ED16F27-0305-4E4A-B984-D118ED8E729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5684955" y="3511292"/>
                        <a:ext cx="3483214" cy="31089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TextBox 15">
            <a:extLst>
              <a:ext uri="{FF2B5EF4-FFF2-40B4-BE49-F238E27FC236}">
                <a16:creationId xmlns:a16="http://schemas.microsoft.com/office/drawing/2014/main" id="{1E08BB0F-8EAF-438B-8762-770AFE7C5469}"/>
              </a:ext>
            </a:extLst>
          </p:cNvPr>
          <p:cNvSpPr txBox="1"/>
          <p:nvPr/>
        </p:nvSpPr>
        <p:spPr>
          <a:xfrm>
            <a:off x="27642" y="462235"/>
            <a:ext cx="3046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3D3FE6C-E0A4-47AA-A746-57EC433B5ACA}"/>
              </a:ext>
            </a:extLst>
          </p:cNvPr>
          <p:cNvSpPr txBox="1"/>
          <p:nvPr/>
        </p:nvSpPr>
        <p:spPr>
          <a:xfrm>
            <a:off x="2957211" y="463323"/>
            <a:ext cx="3046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50C78F9-11B1-4CDA-B4FB-3F69143EB589}"/>
              </a:ext>
            </a:extLst>
          </p:cNvPr>
          <p:cNvSpPr txBox="1"/>
          <p:nvPr/>
        </p:nvSpPr>
        <p:spPr>
          <a:xfrm>
            <a:off x="5737759" y="460383"/>
            <a:ext cx="3046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2C1DD2D-36D6-4775-80C7-C3A70D162751}"/>
              </a:ext>
            </a:extLst>
          </p:cNvPr>
          <p:cNvSpPr txBox="1"/>
          <p:nvPr/>
        </p:nvSpPr>
        <p:spPr>
          <a:xfrm>
            <a:off x="54329" y="3437586"/>
            <a:ext cx="3046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85BF073-DBDB-4DF5-8A6E-41C99432B550}"/>
              </a:ext>
            </a:extLst>
          </p:cNvPr>
          <p:cNvSpPr txBox="1"/>
          <p:nvPr/>
        </p:nvSpPr>
        <p:spPr>
          <a:xfrm>
            <a:off x="2983898" y="3438674"/>
            <a:ext cx="3046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E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675F74E-F526-40FC-AD58-853F8D7B6CAC}"/>
              </a:ext>
            </a:extLst>
          </p:cNvPr>
          <p:cNvSpPr txBox="1"/>
          <p:nvPr/>
        </p:nvSpPr>
        <p:spPr>
          <a:xfrm>
            <a:off x="5764446" y="3435734"/>
            <a:ext cx="3046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B017619-9DA7-8E4C-BADB-572B98A58F17}"/>
              </a:ext>
            </a:extLst>
          </p:cNvPr>
          <p:cNvSpPr txBox="1"/>
          <p:nvPr/>
        </p:nvSpPr>
        <p:spPr>
          <a:xfrm>
            <a:off x="0" y="-7737"/>
            <a:ext cx="2286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1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75AD480-85CC-4EEF-AE02-849DB94D710A}"/>
              </a:ext>
            </a:extLst>
          </p:cNvPr>
          <p:cNvSpPr txBox="1"/>
          <p:nvPr/>
        </p:nvSpPr>
        <p:spPr>
          <a:xfrm>
            <a:off x="228600" y="6423973"/>
            <a:ext cx="902304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Suppl Fig 1 (a-f) Associations between program demographics and some barriers/facilitators.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*p value&lt; 0.05</a:t>
            </a:r>
            <a:r>
              <a:rPr lang="en-US" sz="1400" baseline="0" dirty="0"/>
              <a:t> </a:t>
            </a:r>
            <a:r>
              <a:rPr lang="en-US" sz="1400" dirty="0"/>
              <a:t> 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820691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46</Words>
  <Application>Microsoft Office PowerPoint</Application>
  <PresentationFormat>On-screen Show (4:3)</PresentationFormat>
  <Paragraphs>10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Times New Roman</vt:lpstr>
      <vt:lpstr>Office Theme</vt:lpstr>
      <vt:lpstr>Prism 8</vt:lpstr>
      <vt:lpstr>PowerPoint Presentation</vt:lpstr>
    </vt:vector>
  </TitlesOfParts>
  <Company>Rush University Medical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ush</dc:creator>
  <cp:lastModifiedBy>Nupur Mittal</cp:lastModifiedBy>
  <cp:revision>2</cp:revision>
  <dcterms:created xsi:type="dcterms:W3CDTF">2021-07-14T17:54:52Z</dcterms:created>
  <dcterms:modified xsi:type="dcterms:W3CDTF">2022-01-11T21:34:07Z</dcterms:modified>
</cp:coreProperties>
</file>